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2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552519" y="135449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4233622" y="892828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onditioned medium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>
            <a:cxnSpLocks/>
          </p:cNvCxnSpPr>
          <p:nvPr/>
        </p:nvCxnSpPr>
        <p:spPr>
          <a:xfrm flipV="1">
            <a:off x="3676626" y="1262160"/>
            <a:ext cx="3414622" cy="191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5757D45E-878F-C524-4E83-AFB99007EC38}"/>
              </a:ext>
            </a:extLst>
          </p:cNvPr>
          <p:cNvSpPr txBox="1"/>
          <p:nvPr/>
        </p:nvSpPr>
        <p:spPr>
          <a:xfrm>
            <a:off x="3824559" y="1354493"/>
            <a:ext cx="61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NT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6BF0CF3-2C62-B5FB-4520-7BB17528F41A}"/>
              </a:ext>
            </a:extLst>
          </p:cNvPr>
          <p:cNvSpPr txBox="1"/>
          <p:nvPr/>
        </p:nvSpPr>
        <p:spPr>
          <a:xfrm>
            <a:off x="4793749" y="1354493"/>
            <a:ext cx="1113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CDko#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77E10D-8592-D39B-0175-89174E6A6F9D}"/>
              </a:ext>
            </a:extLst>
          </p:cNvPr>
          <p:cNvSpPr txBox="1"/>
          <p:nvPr/>
        </p:nvSpPr>
        <p:spPr>
          <a:xfrm>
            <a:off x="6046741" y="1354493"/>
            <a:ext cx="1113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CDko#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7578A13-2312-044B-C12F-52F30AC89B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2777" y="1706718"/>
            <a:ext cx="1044507" cy="216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0E8AE01-D71E-1062-F279-2C4DEE7D85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7026" y="1706718"/>
            <a:ext cx="1044507" cy="216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51C7AB1-BFB7-049D-011E-DB8BB179D1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21932" y="1723825"/>
            <a:ext cx="1044507" cy="2160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462D582-8B15-0923-819B-C707F05833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46741" y="1723825"/>
            <a:ext cx="1044507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2129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552519" y="135449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4233622" y="892828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onditioned medium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>
            <a:cxnSpLocks/>
          </p:cNvCxnSpPr>
          <p:nvPr/>
        </p:nvCxnSpPr>
        <p:spPr>
          <a:xfrm flipV="1">
            <a:off x="3676626" y="1262160"/>
            <a:ext cx="3414622" cy="191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5757D45E-878F-C524-4E83-AFB99007EC38}"/>
              </a:ext>
            </a:extLst>
          </p:cNvPr>
          <p:cNvSpPr txBox="1"/>
          <p:nvPr/>
        </p:nvSpPr>
        <p:spPr>
          <a:xfrm>
            <a:off x="3824559" y="1354493"/>
            <a:ext cx="61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NT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6BF0CF3-2C62-B5FB-4520-7BB17528F41A}"/>
              </a:ext>
            </a:extLst>
          </p:cNvPr>
          <p:cNvSpPr txBox="1"/>
          <p:nvPr/>
        </p:nvSpPr>
        <p:spPr>
          <a:xfrm>
            <a:off x="4793749" y="1354493"/>
            <a:ext cx="1113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CDko#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77E10D-8592-D39B-0175-89174E6A6F9D}"/>
              </a:ext>
            </a:extLst>
          </p:cNvPr>
          <p:cNvSpPr txBox="1"/>
          <p:nvPr/>
        </p:nvSpPr>
        <p:spPr>
          <a:xfrm>
            <a:off x="6046741" y="1354493"/>
            <a:ext cx="1113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CDko#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A5E599A-555B-CCD9-9BFC-C5C14D0030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757212" y="2248097"/>
            <a:ext cx="2160000" cy="111145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3F14BB2-FB5F-5F18-CB5D-B61A8C2199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3084112" y="2248096"/>
            <a:ext cx="2160000" cy="111145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87B1233-4B36-5941-5254-84851487FA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4334857" y="2248096"/>
            <a:ext cx="2160000" cy="111145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678E9F7-CEB6-3DE2-6BDF-6EC80812B2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5585602" y="2248095"/>
            <a:ext cx="2160000" cy="11114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8465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552519" y="135449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4233622" y="892828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onditioned medium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>
            <a:cxnSpLocks/>
          </p:cNvCxnSpPr>
          <p:nvPr/>
        </p:nvCxnSpPr>
        <p:spPr>
          <a:xfrm flipV="1">
            <a:off x="3676626" y="1262160"/>
            <a:ext cx="3414622" cy="191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5757D45E-878F-C524-4E83-AFB99007EC38}"/>
              </a:ext>
            </a:extLst>
          </p:cNvPr>
          <p:cNvSpPr txBox="1"/>
          <p:nvPr/>
        </p:nvSpPr>
        <p:spPr>
          <a:xfrm>
            <a:off x="3824559" y="1354493"/>
            <a:ext cx="61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NT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6BF0CF3-2C62-B5FB-4520-7BB17528F41A}"/>
              </a:ext>
            </a:extLst>
          </p:cNvPr>
          <p:cNvSpPr txBox="1"/>
          <p:nvPr/>
        </p:nvSpPr>
        <p:spPr>
          <a:xfrm>
            <a:off x="4793749" y="1354493"/>
            <a:ext cx="1113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CDko#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77E10D-8592-D39B-0175-89174E6A6F9D}"/>
              </a:ext>
            </a:extLst>
          </p:cNvPr>
          <p:cNvSpPr txBox="1"/>
          <p:nvPr/>
        </p:nvSpPr>
        <p:spPr>
          <a:xfrm>
            <a:off x="6046741" y="1354493"/>
            <a:ext cx="1113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CDko#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A150559-F41D-F5D9-B51E-06EA4E0676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4653" y="1723825"/>
            <a:ext cx="1085118" cy="216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B37270C-D339-E493-230B-331547E8CE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723825"/>
            <a:ext cx="1085118" cy="216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9CEE6FC-11A4-58BE-B3B1-3D21647D78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41378" y="1725006"/>
            <a:ext cx="1085118" cy="2160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29B9A64-3DD6-F7F9-1820-75F76C0A18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88398" y="1723825"/>
            <a:ext cx="1085118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4613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9</TotalTime>
  <Words>39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23</cp:revision>
  <dcterms:created xsi:type="dcterms:W3CDTF">2024-06-06T16:34:22Z</dcterms:created>
  <dcterms:modified xsi:type="dcterms:W3CDTF">2024-06-20T13:07:41Z</dcterms:modified>
</cp:coreProperties>
</file>